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-112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13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021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554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012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094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093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117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336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42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697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76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50B13E-D63F-444D-957C-AF60F8C90FAD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4C701-4202-C74F-A7C9-81A1ADA9B09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73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0080340"/>
              </p:ext>
            </p:extLst>
          </p:nvPr>
        </p:nvGraphicFramePr>
        <p:xfrm>
          <a:off x="1016002" y="765367"/>
          <a:ext cx="7022351" cy="5597406"/>
        </p:xfrm>
        <a:graphic>
          <a:graphicData uri="http://schemas.openxmlformats.org/drawingml/2006/table">
            <a:tbl>
              <a:tblPr/>
              <a:tblGrid>
                <a:gridCol w="818016"/>
                <a:gridCol w="818016"/>
                <a:gridCol w="918694"/>
                <a:gridCol w="654413"/>
                <a:gridCol w="679582"/>
                <a:gridCol w="666998"/>
                <a:gridCol w="692167"/>
                <a:gridCol w="692167"/>
                <a:gridCol w="1082298"/>
              </a:tblGrid>
              <a:tr h="1560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up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me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riment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D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A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L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NB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UD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cells (n)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56068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L (-)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0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3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0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up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me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riment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D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A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L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NB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UD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cells (n)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56068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L (+)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3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9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</a:t>
                      </a:r>
                    </a:p>
                  </a:txBody>
                  <a:tcPr marL="10134" marR="10134" marT="101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6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0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8</a:t>
                      </a:r>
                    </a:p>
                  </a:txBody>
                  <a:tcPr marL="10134" marR="10134" marT="101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11413" y="424033"/>
            <a:ext cx="40652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S5 Table Data summary table for figure 4A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240543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96</Words>
  <Application>Microsoft Macintosh PowerPoint</Application>
  <PresentationFormat>On-screen Show (4:3)</PresentationFormat>
  <Paragraphs>18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se Wester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Tartakoff</dc:creator>
  <cp:lastModifiedBy>Alan Tartakoff</cp:lastModifiedBy>
  <cp:revision>2</cp:revision>
  <dcterms:created xsi:type="dcterms:W3CDTF">2017-03-10T17:54:16Z</dcterms:created>
  <dcterms:modified xsi:type="dcterms:W3CDTF">2017-03-10T17:58:20Z</dcterms:modified>
</cp:coreProperties>
</file>